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omments/comment1.xml" ContentType="application/vnd.openxmlformats-officedocument.presentationml.comment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72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S.M. Wilting" initials="SW" lastIdx="9" clrIdx="0">
    <p:extLst>
      <p:ext uri="{19B8F6BF-5375-455C-9EA6-DF929625EA0E}">
        <p15:presenceInfo xmlns:p15="http://schemas.microsoft.com/office/powerpoint/2012/main" userId="S-1-5-21-932686498-1610486119-1155464205-202869" providerId="AD"/>
      </p:ext>
    </p:extLst>
  </p:cmAuthor>
  <p:cmAuthor id="2" name="T. Deger" initials="TD" lastIdx="2" clrIdx="1">
    <p:extLst>
      <p:ext uri="{19B8F6BF-5375-455C-9EA6-DF929625EA0E}">
        <p15:presenceInfo xmlns:p15="http://schemas.microsoft.com/office/powerpoint/2012/main" userId="S-1-5-21-932686498-1610486119-1155464205-240663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B21C5"/>
    <a:srgbClr val="4565EB"/>
    <a:srgbClr val="AD4FE1"/>
    <a:srgbClr val="5B9BD5"/>
    <a:srgbClr val="A020F0"/>
    <a:srgbClr val="96919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699" autoAdjust="0"/>
    <p:restoredTop sz="97459" autoAdjust="0"/>
  </p:normalViewPr>
  <p:slideViewPr>
    <p:cSldViewPr snapToGrid="0">
      <p:cViewPr varScale="1">
        <p:scale>
          <a:sx n="60" d="100"/>
          <a:sy n="60" d="100"/>
        </p:scale>
        <p:origin x="1926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omments/comment1.xml><?xml version="1.0" encoding="utf-8"?>
<p:cmLst xmlns:a="http://schemas.openxmlformats.org/drawingml/2006/main" xmlns:r="http://schemas.openxmlformats.org/officeDocument/2006/relationships" xmlns:p="http://schemas.openxmlformats.org/presentationml/2006/main">
  <p:cm authorId="1" dt="2021-07-06T14:06:37.051" idx="8">
    <p:pos x="10" y="10"/>
    <p:text>bij de andere suppl figures staat er een titel bij?</p:text>
    <p:extLst>
      <p:ext uri="{C676402C-5697-4E1C-873F-D02D1690AC5C}">
        <p15:threadingInfo xmlns:p15="http://schemas.microsoft.com/office/powerpoint/2012/main" timeZoneBias="-120"/>
      </p:ext>
    </p:extLst>
  </p:cm>
</p:cmLst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50E9C5-A077-49EB-BDE6-1DA9E901EF56}" type="datetimeFigureOut">
              <a:rPr lang="en-GB" smtClean="0"/>
              <a:t>09/10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A0D5A4-4C1A-40C2-B5BC-23EDC148767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958510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50E9C5-A077-49EB-BDE6-1DA9E901EF56}" type="datetimeFigureOut">
              <a:rPr lang="en-GB" smtClean="0"/>
              <a:t>09/10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A0D5A4-4C1A-40C2-B5BC-23EDC148767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184354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50E9C5-A077-49EB-BDE6-1DA9E901EF56}" type="datetimeFigureOut">
              <a:rPr lang="en-GB" smtClean="0"/>
              <a:t>09/10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A0D5A4-4C1A-40C2-B5BC-23EDC148767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967372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50E9C5-A077-49EB-BDE6-1DA9E901EF56}" type="datetimeFigureOut">
              <a:rPr lang="en-GB" smtClean="0"/>
              <a:t>09/10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A0D5A4-4C1A-40C2-B5BC-23EDC148767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709304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50E9C5-A077-49EB-BDE6-1DA9E901EF56}" type="datetimeFigureOut">
              <a:rPr lang="en-GB" smtClean="0"/>
              <a:t>09/10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A0D5A4-4C1A-40C2-B5BC-23EDC148767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994058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50E9C5-A077-49EB-BDE6-1DA9E901EF56}" type="datetimeFigureOut">
              <a:rPr lang="en-GB" smtClean="0"/>
              <a:t>09/10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A0D5A4-4C1A-40C2-B5BC-23EDC148767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536917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50E9C5-A077-49EB-BDE6-1DA9E901EF56}" type="datetimeFigureOut">
              <a:rPr lang="en-GB" smtClean="0"/>
              <a:t>09/10/2021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A0D5A4-4C1A-40C2-B5BC-23EDC148767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496785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50E9C5-A077-49EB-BDE6-1DA9E901EF56}" type="datetimeFigureOut">
              <a:rPr lang="en-GB" smtClean="0"/>
              <a:t>09/10/20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A0D5A4-4C1A-40C2-B5BC-23EDC148767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590540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50E9C5-A077-49EB-BDE6-1DA9E901EF56}" type="datetimeFigureOut">
              <a:rPr lang="en-GB" smtClean="0"/>
              <a:t>09/10/2021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A0D5A4-4C1A-40C2-B5BC-23EDC148767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966647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50E9C5-A077-49EB-BDE6-1DA9E901EF56}" type="datetimeFigureOut">
              <a:rPr lang="en-GB" smtClean="0"/>
              <a:t>09/10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A0D5A4-4C1A-40C2-B5BC-23EDC148767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524234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50E9C5-A077-49EB-BDE6-1DA9E901EF56}" type="datetimeFigureOut">
              <a:rPr lang="en-GB" smtClean="0"/>
              <a:t>09/10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A0D5A4-4C1A-40C2-B5BC-23EDC148767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784020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50E9C5-A077-49EB-BDE6-1DA9E901EF56}" type="datetimeFigureOut">
              <a:rPr lang="en-GB" smtClean="0"/>
              <a:t>09/10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A0D5A4-4C1A-40C2-B5BC-23EDC148767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259530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4" Type="http://schemas.openxmlformats.org/officeDocument/2006/relationships/comments" Target="../comments/commen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0" y="16643"/>
            <a:ext cx="68580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/>
              <a:t>Supplementary Figure </a:t>
            </a:r>
            <a:r>
              <a:rPr lang="en-US" sz="1100" dirty="0" smtClean="0"/>
              <a:t>3 </a:t>
            </a:r>
            <a:endParaRPr lang="en-GB" sz="1100" dirty="0"/>
          </a:p>
        </p:txBody>
      </p:sp>
      <p:graphicFrame>
        <p:nvGraphicFramePr>
          <p:cNvPr id="6" name="Table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9746533"/>
              </p:ext>
            </p:extLst>
          </p:nvPr>
        </p:nvGraphicFramePr>
        <p:xfrm>
          <a:off x="5459413" y="421005"/>
          <a:ext cx="665162" cy="832104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665162">
                  <a:extLst>
                    <a:ext uri="{9D8B030D-6E8A-4147-A177-3AD203B41FA5}">
                      <a16:colId xmlns="" xmlns:a16="http://schemas.microsoft.com/office/drawing/2014/main" val="400665332"/>
                    </a:ext>
                  </a:extLst>
                </a:gridCol>
              </a:tblGrid>
              <a:tr h="99738">
                <a:tc>
                  <a:txBody>
                    <a:bodyPr/>
                    <a:lstStyle/>
                    <a:p>
                      <a:pPr algn="l" fontAlgn="b"/>
                      <a:r>
                        <a:rPr lang="nl-NL" sz="700" u="none" strike="noStrike">
                          <a:effectLst/>
                        </a:rPr>
                        <a:t>CD3D</a:t>
                      </a:r>
                      <a:endParaRPr lang="nl-NL" sz="7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4209639395"/>
                  </a:ext>
                </a:extLst>
              </a:tr>
              <a:tr h="99738">
                <a:tc>
                  <a:txBody>
                    <a:bodyPr/>
                    <a:lstStyle/>
                    <a:p>
                      <a:pPr algn="l" fontAlgn="b"/>
                      <a:r>
                        <a:rPr lang="nl-NL" sz="700" u="none" strike="noStrike">
                          <a:effectLst/>
                        </a:rPr>
                        <a:t>CD7</a:t>
                      </a:r>
                      <a:endParaRPr lang="nl-NL" sz="7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2760377495"/>
                  </a:ext>
                </a:extLst>
              </a:tr>
              <a:tr h="99738">
                <a:tc>
                  <a:txBody>
                    <a:bodyPr/>
                    <a:lstStyle/>
                    <a:p>
                      <a:pPr algn="l" fontAlgn="b"/>
                      <a:r>
                        <a:rPr lang="nl-NL" sz="700" u="none" strike="noStrike">
                          <a:effectLst/>
                        </a:rPr>
                        <a:t>CEBPE</a:t>
                      </a:r>
                      <a:endParaRPr lang="nl-NL" sz="7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2886951890"/>
                  </a:ext>
                </a:extLst>
              </a:tr>
              <a:tr h="99738">
                <a:tc>
                  <a:txBody>
                    <a:bodyPr/>
                    <a:lstStyle/>
                    <a:p>
                      <a:pPr algn="l" fontAlgn="b"/>
                      <a:r>
                        <a:rPr lang="nl-NL" sz="700" u="none" strike="noStrike">
                          <a:effectLst/>
                        </a:rPr>
                        <a:t>BRD4</a:t>
                      </a:r>
                      <a:endParaRPr lang="nl-NL" sz="7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682817516"/>
                  </a:ext>
                </a:extLst>
              </a:tr>
              <a:tr h="99738">
                <a:tc>
                  <a:txBody>
                    <a:bodyPr/>
                    <a:lstStyle/>
                    <a:p>
                      <a:pPr algn="l" fontAlgn="b"/>
                      <a:r>
                        <a:rPr lang="nl-NL" sz="700" u="none" strike="noStrike">
                          <a:effectLst/>
                        </a:rPr>
                        <a:t>FGD2</a:t>
                      </a:r>
                      <a:endParaRPr lang="nl-NL" sz="7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2950451092"/>
                  </a:ext>
                </a:extLst>
              </a:tr>
              <a:tr h="99738">
                <a:tc>
                  <a:txBody>
                    <a:bodyPr/>
                    <a:lstStyle/>
                    <a:p>
                      <a:pPr algn="l" fontAlgn="b"/>
                      <a:r>
                        <a:rPr lang="nl-NL" sz="700" u="none" strike="noStrike">
                          <a:effectLst/>
                        </a:rPr>
                        <a:t>NCR1</a:t>
                      </a:r>
                      <a:endParaRPr lang="nl-NL" sz="7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2378208814"/>
                  </a:ext>
                </a:extLst>
              </a:tr>
              <a:tr h="99738">
                <a:tc>
                  <a:txBody>
                    <a:bodyPr/>
                    <a:lstStyle/>
                    <a:p>
                      <a:pPr algn="l" fontAlgn="b"/>
                      <a:r>
                        <a:rPr lang="nl-NL" sz="700" u="none" strike="noStrike">
                          <a:effectLst/>
                        </a:rPr>
                        <a:t>BLK</a:t>
                      </a:r>
                      <a:endParaRPr lang="nl-NL" sz="7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4058643270"/>
                  </a:ext>
                </a:extLst>
              </a:tr>
              <a:tr h="99738">
                <a:tc>
                  <a:txBody>
                    <a:bodyPr/>
                    <a:lstStyle/>
                    <a:p>
                      <a:pPr algn="l" fontAlgn="b"/>
                      <a:r>
                        <a:rPr lang="nl-NL" sz="700" u="none" strike="noStrike">
                          <a:effectLst/>
                        </a:rPr>
                        <a:t>EDAR</a:t>
                      </a:r>
                      <a:endParaRPr lang="nl-NL" sz="7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3774046575"/>
                  </a:ext>
                </a:extLst>
              </a:tr>
              <a:tr h="99738">
                <a:tc>
                  <a:txBody>
                    <a:bodyPr/>
                    <a:lstStyle/>
                    <a:p>
                      <a:pPr algn="l" fontAlgn="b"/>
                      <a:r>
                        <a:rPr lang="nl-NL" sz="700" u="none" strike="noStrike">
                          <a:effectLst/>
                        </a:rPr>
                        <a:t>EPS8L3</a:t>
                      </a:r>
                      <a:endParaRPr lang="nl-NL" sz="7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2426368863"/>
                  </a:ext>
                </a:extLst>
              </a:tr>
              <a:tr h="99738">
                <a:tc>
                  <a:txBody>
                    <a:bodyPr/>
                    <a:lstStyle/>
                    <a:p>
                      <a:pPr algn="l" fontAlgn="b"/>
                      <a:r>
                        <a:rPr lang="nl-NL" sz="700" u="none" strike="noStrike">
                          <a:effectLst/>
                        </a:rPr>
                        <a:t>CALML4</a:t>
                      </a:r>
                      <a:endParaRPr lang="nl-NL" sz="7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4192027313"/>
                  </a:ext>
                </a:extLst>
              </a:tr>
              <a:tr h="99738">
                <a:tc>
                  <a:txBody>
                    <a:bodyPr/>
                    <a:lstStyle/>
                    <a:p>
                      <a:pPr algn="l" fontAlgn="b"/>
                      <a:r>
                        <a:rPr lang="nl-NL" sz="700" u="none" strike="noStrike">
                          <a:effectLst/>
                        </a:rPr>
                        <a:t>DOK3</a:t>
                      </a:r>
                      <a:endParaRPr lang="nl-NL" sz="7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458326102"/>
                  </a:ext>
                </a:extLst>
              </a:tr>
              <a:tr h="99738">
                <a:tc>
                  <a:txBody>
                    <a:bodyPr/>
                    <a:lstStyle/>
                    <a:p>
                      <a:pPr algn="l" fontAlgn="b"/>
                      <a:r>
                        <a:rPr lang="nl-NL" sz="700" u="none" strike="noStrike">
                          <a:effectLst/>
                        </a:rPr>
                        <a:t>GPR97</a:t>
                      </a:r>
                      <a:endParaRPr lang="nl-NL" sz="7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996818314"/>
                  </a:ext>
                </a:extLst>
              </a:tr>
              <a:tr h="99738">
                <a:tc>
                  <a:txBody>
                    <a:bodyPr/>
                    <a:lstStyle/>
                    <a:p>
                      <a:pPr algn="l" fontAlgn="b"/>
                      <a:r>
                        <a:rPr lang="nl-NL" sz="700" u="none" strike="noStrike">
                          <a:effectLst/>
                        </a:rPr>
                        <a:t>SH3TC1</a:t>
                      </a:r>
                      <a:endParaRPr lang="nl-NL" sz="7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3715024624"/>
                  </a:ext>
                </a:extLst>
              </a:tr>
              <a:tr h="99738">
                <a:tc>
                  <a:txBody>
                    <a:bodyPr/>
                    <a:lstStyle/>
                    <a:p>
                      <a:pPr algn="l" fontAlgn="b"/>
                      <a:r>
                        <a:rPr lang="nl-NL" sz="700" u="none" strike="noStrike">
                          <a:effectLst/>
                        </a:rPr>
                        <a:t>CEL</a:t>
                      </a:r>
                      <a:endParaRPr lang="nl-NL" sz="7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2667580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nl-NL" sz="700" u="none" strike="noStrike">
                          <a:effectLst/>
                        </a:rPr>
                        <a:t>PDCD1</a:t>
                      </a:r>
                      <a:endParaRPr lang="nl-NL" sz="7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844776564"/>
                  </a:ext>
                </a:extLst>
              </a:tr>
              <a:tr h="99738">
                <a:tc>
                  <a:txBody>
                    <a:bodyPr/>
                    <a:lstStyle/>
                    <a:p>
                      <a:pPr algn="l" fontAlgn="b"/>
                      <a:r>
                        <a:rPr lang="nl-NL" sz="700" u="none" strike="noStrike">
                          <a:effectLst/>
                        </a:rPr>
                        <a:t>RPS6KA1</a:t>
                      </a:r>
                      <a:endParaRPr lang="nl-NL" sz="7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643390046"/>
                  </a:ext>
                </a:extLst>
              </a:tr>
              <a:tr h="99738">
                <a:tc>
                  <a:txBody>
                    <a:bodyPr/>
                    <a:lstStyle/>
                    <a:p>
                      <a:pPr algn="l" fontAlgn="b"/>
                      <a:r>
                        <a:rPr lang="nl-NL" sz="700" u="none" strike="noStrike">
                          <a:effectLst/>
                        </a:rPr>
                        <a:t>HBEGF</a:t>
                      </a:r>
                      <a:endParaRPr lang="nl-NL" sz="7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55459731"/>
                  </a:ext>
                </a:extLst>
              </a:tr>
              <a:tr h="99738">
                <a:tc>
                  <a:txBody>
                    <a:bodyPr/>
                    <a:lstStyle/>
                    <a:p>
                      <a:pPr algn="l" fontAlgn="b"/>
                      <a:r>
                        <a:rPr lang="nl-NL" sz="700" u="none" strike="noStrike">
                          <a:effectLst/>
                        </a:rPr>
                        <a:t>CLDN15</a:t>
                      </a:r>
                      <a:endParaRPr lang="nl-NL" sz="7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3510108393"/>
                  </a:ext>
                </a:extLst>
              </a:tr>
              <a:tr h="99738">
                <a:tc>
                  <a:txBody>
                    <a:bodyPr/>
                    <a:lstStyle/>
                    <a:p>
                      <a:pPr algn="l" fontAlgn="b"/>
                      <a:r>
                        <a:rPr lang="nl-NL" sz="700" u="none" strike="noStrike">
                          <a:effectLst/>
                        </a:rPr>
                        <a:t>TNFSF14</a:t>
                      </a:r>
                      <a:endParaRPr lang="nl-NL" sz="7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3229303102"/>
                  </a:ext>
                </a:extLst>
              </a:tr>
              <a:tr h="99738">
                <a:tc>
                  <a:txBody>
                    <a:bodyPr/>
                    <a:lstStyle/>
                    <a:p>
                      <a:pPr algn="l" fontAlgn="b"/>
                      <a:r>
                        <a:rPr lang="nl-NL" sz="700" u="none" strike="noStrike">
                          <a:effectLst/>
                        </a:rPr>
                        <a:t>CTSZ</a:t>
                      </a:r>
                      <a:endParaRPr lang="nl-NL" sz="7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250398008"/>
                  </a:ext>
                </a:extLst>
              </a:tr>
              <a:tr h="99738">
                <a:tc>
                  <a:txBody>
                    <a:bodyPr/>
                    <a:lstStyle/>
                    <a:p>
                      <a:pPr algn="l" fontAlgn="b"/>
                      <a:r>
                        <a:rPr lang="nl-NL" sz="700" u="none" strike="noStrike">
                          <a:effectLst/>
                        </a:rPr>
                        <a:t>PRR5</a:t>
                      </a:r>
                      <a:endParaRPr lang="nl-NL" sz="7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341973265"/>
                  </a:ext>
                </a:extLst>
              </a:tr>
              <a:tr h="99738">
                <a:tc>
                  <a:txBody>
                    <a:bodyPr/>
                    <a:lstStyle/>
                    <a:p>
                      <a:pPr algn="l" fontAlgn="b"/>
                      <a:r>
                        <a:rPr lang="nl-NL" sz="700" u="none" strike="noStrike">
                          <a:effectLst/>
                        </a:rPr>
                        <a:t>FASLG</a:t>
                      </a:r>
                      <a:endParaRPr lang="nl-NL" sz="7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4039996194"/>
                  </a:ext>
                </a:extLst>
              </a:tr>
              <a:tr h="99738">
                <a:tc>
                  <a:txBody>
                    <a:bodyPr/>
                    <a:lstStyle/>
                    <a:p>
                      <a:pPr algn="l" fontAlgn="b"/>
                      <a:r>
                        <a:rPr lang="nl-NL" sz="700" u="none" strike="noStrike">
                          <a:effectLst/>
                        </a:rPr>
                        <a:t>HDC</a:t>
                      </a:r>
                      <a:endParaRPr lang="nl-NL" sz="7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3083943316"/>
                  </a:ext>
                </a:extLst>
              </a:tr>
              <a:tr h="99738">
                <a:tc>
                  <a:txBody>
                    <a:bodyPr/>
                    <a:lstStyle/>
                    <a:p>
                      <a:pPr algn="l" fontAlgn="b"/>
                      <a:r>
                        <a:rPr lang="nl-NL" sz="700" u="none" strike="noStrike">
                          <a:effectLst/>
                        </a:rPr>
                        <a:t>ANGPTL2</a:t>
                      </a:r>
                      <a:endParaRPr lang="nl-NL" sz="7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4064685686"/>
                  </a:ext>
                </a:extLst>
              </a:tr>
              <a:tr h="99738">
                <a:tc>
                  <a:txBody>
                    <a:bodyPr/>
                    <a:lstStyle/>
                    <a:p>
                      <a:pPr algn="l" fontAlgn="b"/>
                      <a:r>
                        <a:rPr lang="nl-NL" sz="700" u="none" strike="noStrike">
                          <a:effectLst/>
                        </a:rPr>
                        <a:t>FLJ42393</a:t>
                      </a:r>
                      <a:endParaRPr lang="nl-NL" sz="7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578444627"/>
                  </a:ext>
                </a:extLst>
              </a:tr>
              <a:tr h="99738">
                <a:tc>
                  <a:txBody>
                    <a:bodyPr/>
                    <a:lstStyle/>
                    <a:p>
                      <a:pPr algn="l" fontAlgn="b"/>
                      <a:r>
                        <a:rPr lang="nl-NL" sz="700" u="none" strike="noStrike">
                          <a:effectLst/>
                        </a:rPr>
                        <a:t>TFR2</a:t>
                      </a:r>
                      <a:endParaRPr lang="nl-NL" sz="7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2181500690"/>
                  </a:ext>
                </a:extLst>
              </a:tr>
              <a:tr h="99738">
                <a:tc>
                  <a:txBody>
                    <a:bodyPr/>
                    <a:lstStyle/>
                    <a:p>
                      <a:pPr algn="l" fontAlgn="b"/>
                      <a:r>
                        <a:rPr lang="nl-NL" sz="700" u="none" strike="noStrike">
                          <a:effectLst/>
                        </a:rPr>
                        <a:t>FGR</a:t>
                      </a:r>
                      <a:endParaRPr lang="nl-NL" sz="7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3059248590"/>
                  </a:ext>
                </a:extLst>
              </a:tr>
              <a:tr h="99738">
                <a:tc>
                  <a:txBody>
                    <a:bodyPr/>
                    <a:lstStyle/>
                    <a:p>
                      <a:pPr algn="l" fontAlgn="b"/>
                      <a:r>
                        <a:rPr lang="nl-NL" sz="700" u="none" strike="noStrike">
                          <a:effectLst/>
                        </a:rPr>
                        <a:t>NR1H3</a:t>
                      </a:r>
                      <a:endParaRPr lang="nl-NL" sz="7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989975325"/>
                  </a:ext>
                </a:extLst>
              </a:tr>
              <a:tr h="99738">
                <a:tc>
                  <a:txBody>
                    <a:bodyPr/>
                    <a:lstStyle/>
                    <a:p>
                      <a:pPr algn="l" fontAlgn="b"/>
                      <a:r>
                        <a:rPr lang="nl-NL" sz="700" u="none" strike="noStrike">
                          <a:effectLst/>
                        </a:rPr>
                        <a:t>CST8</a:t>
                      </a:r>
                      <a:endParaRPr lang="nl-NL" sz="7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950358318"/>
                  </a:ext>
                </a:extLst>
              </a:tr>
              <a:tr h="99738">
                <a:tc>
                  <a:txBody>
                    <a:bodyPr/>
                    <a:lstStyle/>
                    <a:p>
                      <a:pPr algn="l" fontAlgn="b"/>
                      <a:r>
                        <a:rPr lang="nl-NL" sz="700" u="none" strike="noStrike">
                          <a:effectLst/>
                        </a:rPr>
                        <a:t>NAT8</a:t>
                      </a:r>
                      <a:endParaRPr lang="nl-NL" sz="7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126543265"/>
                  </a:ext>
                </a:extLst>
              </a:tr>
              <a:tr h="99738">
                <a:tc>
                  <a:txBody>
                    <a:bodyPr/>
                    <a:lstStyle/>
                    <a:p>
                      <a:pPr algn="l" fontAlgn="b"/>
                      <a:r>
                        <a:rPr lang="nl-NL" sz="700" u="none" strike="noStrike">
                          <a:effectLst/>
                        </a:rPr>
                        <a:t>ZNF22</a:t>
                      </a:r>
                      <a:endParaRPr lang="nl-NL" sz="7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2844475707"/>
                  </a:ext>
                </a:extLst>
              </a:tr>
              <a:tr h="99738">
                <a:tc>
                  <a:txBody>
                    <a:bodyPr/>
                    <a:lstStyle/>
                    <a:p>
                      <a:pPr algn="l" fontAlgn="b"/>
                      <a:r>
                        <a:rPr lang="nl-NL" sz="700" u="none" strike="noStrike">
                          <a:effectLst/>
                        </a:rPr>
                        <a:t>CIZ1</a:t>
                      </a:r>
                      <a:endParaRPr lang="nl-NL" sz="7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272276982"/>
                  </a:ext>
                </a:extLst>
              </a:tr>
              <a:tr h="99738">
                <a:tc>
                  <a:txBody>
                    <a:bodyPr/>
                    <a:lstStyle/>
                    <a:p>
                      <a:pPr algn="l" fontAlgn="b"/>
                      <a:r>
                        <a:rPr lang="nl-NL" sz="700" u="none" strike="noStrike">
                          <a:effectLst/>
                        </a:rPr>
                        <a:t>FCN1</a:t>
                      </a:r>
                      <a:endParaRPr lang="nl-NL" sz="7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2722530"/>
                  </a:ext>
                </a:extLst>
              </a:tr>
              <a:tr h="99738">
                <a:tc>
                  <a:txBody>
                    <a:bodyPr/>
                    <a:lstStyle/>
                    <a:p>
                      <a:pPr algn="l" fontAlgn="b"/>
                      <a:r>
                        <a:rPr lang="nl-NL" sz="700" u="none" strike="noStrike">
                          <a:effectLst/>
                        </a:rPr>
                        <a:t>CRTAM</a:t>
                      </a:r>
                      <a:endParaRPr lang="nl-NL" sz="7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559768517"/>
                  </a:ext>
                </a:extLst>
              </a:tr>
              <a:tr h="99738">
                <a:tc>
                  <a:txBody>
                    <a:bodyPr/>
                    <a:lstStyle/>
                    <a:p>
                      <a:pPr algn="l" fontAlgn="b"/>
                      <a:r>
                        <a:rPr lang="nl-NL" sz="700" u="none" strike="noStrike">
                          <a:effectLst/>
                        </a:rPr>
                        <a:t>SFTPD</a:t>
                      </a:r>
                      <a:endParaRPr lang="nl-NL" sz="7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407477249"/>
                  </a:ext>
                </a:extLst>
              </a:tr>
              <a:tr h="99738">
                <a:tc>
                  <a:txBody>
                    <a:bodyPr/>
                    <a:lstStyle/>
                    <a:p>
                      <a:pPr algn="l" fontAlgn="b"/>
                      <a:r>
                        <a:rPr lang="nl-NL" sz="700" u="none" strike="noStrike">
                          <a:effectLst/>
                        </a:rPr>
                        <a:t>PLCB2</a:t>
                      </a:r>
                      <a:endParaRPr lang="nl-NL" sz="7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510378768"/>
                  </a:ext>
                </a:extLst>
              </a:tr>
              <a:tr h="99738">
                <a:tc>
                  <a:txBody>
                    <a:bodyPr/>
                    <a:lstStyle/>
                    <a:p>
                      <a:pPr algn="l" fontAlgn="b"/>
                      <a:r>
                        <a:rPr lang="nl-NL" sz="700" u="none" strike="noStrike">
                          <a:effectLst/>
                        </a:rPr>
                        <a:t>ACOT11</a:t>
                      </a:r>
                      <a:endParaRPr lang="nl-NL" sz="7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2555284331"/>
                  </a:ext>
                </a:extLst>
              </a:tr>
              <a:tr h="99738">
                <a:tc>
                  <a:txBody>
                    <a:bodyPr/>
                    <a:lstStyle/>
                    <a:p>
                      <a:pPr algn="l" fontAlgn="b"/>
                      <a:r>
                        <a:rPr lang="nl-NL" sz="700" u="none" strike="noStrike">
                          <a:effectLst/>
                        </a:rPr>
                        <a:t>DOPEY2</a:t>
                      </a:r>
                      <a:endParaRPr lang="nl-NL" sz="7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2610643815"/>
                  </a:ext>
                </a:extLst>
              </a:tr>
              <a:tr h="99738">
                <a:tc>
                  <a:txBody>
                    <a:bodyPr/>
                    <a:lstStyle/>
                    <a:p>
                      <a:pPr algn="l" fontAlgn="b"/>
                      <a:r>
                        <a:rPr lang="nl-NL" sz="700" u="none" strike="noStrike">
                          <a:effectLst/>
                        </a:rPr>
                        <a:t>ADORA3</a:t>
                      </a:r>
                      <a:endParaRPr lang="nl-NL" sz="7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3501734704"/>
                  </a:ext>
                </a:extLst>
              </a:tr>
              <a:tr h="99738">
                <a:tc>
                  <a:txBody>
                    <a:bodyPr/>
                    <a:lstStyle/>
                    <a:p>
                      <a:pPr algn="l" fontAlgn="b"/>
                      <a:r>
                        <a:rPr lang="nl-NL" sz="700" u="none" strike="noStrike">
                          <a:effectLst/>
                        </a:rPr>
                        <a:t>FAM65A</a:t>
                      </a:r>
                      <a:endParaRPr lang="nl-NL" sz="7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2581570656"/>
                  </a:ext>
                </a:extLst>
              </a:tr>
              <a:tr h="99738">
                <a:tc>
                  <a:txBody>
                    <a:bodyPr/>
                    <a:lstStyle/>
                    <a:p>
                      <a:pPr algn="l" fontAlgn="b"/>
                      <a:r>
                        <a:rPr lang="nl-NL" sz="700" u="none" strike="noStrike">
                          <a:effectLst/>
                        </a:rPr>
                        <a:t>KSR1</a:t>
                      </a:r>
                      <a:endParaRPr lang="nl-NL" sz="7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993087171"/>
                  </a:ext>
                </a:extLst>
              </a:tr>
              <a:tr h="99738">
                <a:tc>
                  <a:txBody>
                    <a:bodyPr/>
                    <a:lstStyle/>
                    <a:p>
                      <a:pPr algn="l" fontAlgn="b"/>
                      <a:r>
                        <a:rPr lang="nl-NL" sz="700" u="none" strike="noStrike">
                          <a:effectLst/>
                        </a:rPr>
                        <a:t>LY86</a:t>
                      </a:r>
                      <a:endParaRPr lang="nl-NL" sz="7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3940511634"/>
                  </a:ext>
                </a:extLst>
              </a:tr>
              <a:tr h="99738">
                <a:tc>
                  <a:txBody>
                    <a:bodyPr/>
                    <a:lstStyle/>
                    <a:p>
                      <a:pPr algn="l" fontAlgn="b"/>
                      <a:r>
                        <a:rPr lang="nl-NL" sz="700" u="none" strike="noStrike">
                          <a:effectLst/>
                        </a:rPr>
                        <a:t>LDB2</a:t>
                      </a:r>
                      <a:endParaRPr lang="nl-NL" sz="7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765606174"/>
                  </a:ext>
                </a:extLst>
              </a:tr>
              <a:tr h="99738">
                <a:tc>
                  <a:txBody>
                    <a:bodyPr/>
                    <a:lstStyle/>
                    <a:p>
                      <a:pPr algn="l" fontAlgn="b"/>
                      <a:r>
                        <a:rPr lang="nl-NL" sz="700" u="none" strike="noStrike">
                          <a:effectLst/>
                        </a:rPr>
                        <a:t>TREML1</a:t>
                      </a:r>
                      <a:endParaRPr lang="nl-NL" sz="7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471773524"/>
                  </a:ext>
                </a:extLst>
              </a:tr>
              <a:tr h="99738">
                <a:tc>
                  <a:txBody>
                    <a:bodyPr/>
                    <a:lstStyle/>
                    <a:p>
                      <a:pPr algn="l" fontAlgn="b"/>
                      <a:r>
                        <a:rPr lang="nl-NL" sz="700" u="none" strike="noStrike">
                          <a:effectLst/>
                        </a:rPr>
                        <a:t>FAIM</a:t>
                      </a:r>
                      <a:endParaRPr lang="nl-NL" sz="7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526195183"/>
                  </a:ext>
                </a:extLst>
              </a:tr>
              <a:tr h="99738">
                <a:tc>
                  <a:txBody>
                    <a:bodyPr/>
                    <a:lstStyle/>
                    <a:p>
                      <a:pPr algn="l" fontAlgn="b"/>
                      <a:r>
                        <a:rPr lang="nl-NL" sz="700" u="none" strike="noStrike">
                          <a:effectLst/>
                        </a:rPr>
                        <a:t>LMO2</a:t>
                      </a:r>
                      <a:endParaRPr lang="nl-NL" sz="7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911614812"/>
                  </a:ext>
                </a:extLst>
              </a:tr>
              <a:tr h="99738">
                <a:tc>
                  <a:txBody>
                    <a:bodyPr/>
                    <a:lstStyle/>
                    <a:p>
                      <a:pPr algn="l" fontAlgn="b"/>
                      <a:r>
                        <a:rPr lang="nl-NL" sz="700" u="none" strike="noStrike">
                          <a:effectLst/>
                        </a:rPr>
                        <a:t>CD22</a:t>
                      </a:r>
                      <a:endParaRPr lang="nl-NL" sz="7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276497332"/>
                  </a:ext>
                </a:extLst>
              </a:tr>
              <a:tr h="99738">
                <a:tc>
                  <a:txBody>
                    <a:bodyPr/>
                    <a:lstStyle/>
                    <a:p>
                      <a:pPr algn="l" fontAlgn="b"/>
                      <a:r>
                        <a:rPr lang="nl-NL" sz="700" u="none" strike="noStrike">
                          <a:effectLst/>
                        </a:rPr>
                        <a:t>CD300LB</a:t>
                      </a:r>
                      <a:endParaRPr lang="nl-NL" sz="7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4102671572"/>
                  </a:ext>
                </a:extLst>
              </a:tr>
              <a:tr h="99738">
                <a:tc>
                  <a:txBody>
                    <a:bodyPr/>
                    <a:lstStyle/>
                    <a:p>
                      <a:pPr algn="l" fontAlgn="b"/>
                      <a:r>
                        <a:rPr lang="nl-NL" sz="700" u="none" strike="noStrike">
                          <a:effectLst/>
                        </a:rPr>
                        <a:t>LGALS4</a:t>
                      </a:r>
                      <a:endParaRPr lang="nl-NL" sz="7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716791391"/>
                  </a:ext>
                </a:extLst>
              </a:tr>
              <a:tr h="99738">
                <a:tc>
                  <a:txBody>
                    <a:bodyPr/>
                    <a:lstStyle/>
                    <a:p>
                      <a:pPr algn="l" fontAlgn="b"/>
                      <a:r>
                        <a:rPr lang="nl-NL" sz="700" u="none" strike="noStrike">
                          <a:effectLst/>
                        </a:rPr>
                        <a:t>PPP6C</a:t>
                      </a:r>
                      <a:endParaRPr lang="nl-NL" sz="7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14001534"/>
                  </a:ext>
                </a:extLst>
              </a:tr>
              <a:tr h="99738">
                <a:tc>
                  <a:txBody>
                    <a:bodyPr/>
                    <a:lstStyle/>
                    <a:p>
                      <a:pPr algn="l" fontAlgn="b"/>
                      <a:r>
                        <a:rPr lang="nl-NL" sz="700" u="none" strike="noStrike">
                          <a:effectLst/>
                        </a:rPr>
                        <a:t>SFT2D3</a:t>
                      </a:r>
                      <a:endParaRPr lang="nl-NL" sz="7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3182186703"/>
                  </a:ext>
                </a:extLst>
              </a:tr>
              <a:tr h="99738">
                <a:tc>
                  <a:txBody>
                    <a:bodyPr/>
                    <a:lstStyle/>
                    <a:p>
                      <a:pPr algn="l" fontAlgn="b"/>
                      <a:r>
                        <a:rPr lang="nl-NL" sz="700" u="none" strike="noStrike">
                          <a:effectLst/>
                        </a:rPr>
                        <a:t>TNFAIP8</a:t>
                      </a:r>
                      <a:endParaRPr lang="nl-NL" sz="7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218891641"/>
                  </a:ext>
                </a:extLst>
              </a:tr>
              <a:tr h="99738">
                <a:tc>
                  <a:txBody>
                    <a:bodyPr/>
                    <a:lstStyle/>
                    <a:p>
                      <a:pPr algn="l" fontAlgn="b"/>
                      <a:r>
                        <a:rPr lang="nl-NL" sz="700" u="none" strike="noStrike">
                          <a:effectLst/>
                        </a:rPr>
                        <a:t>ALDH3B1</a:t>
                      </a:r>
                      <a:endParaRPr lang="nl-NL" sz="7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3201103329"/>
                  </a:ext>
                </a:extLst>
              </a:tr>
              <a:tr h="99738">
                <a:tc>
                  <a:txBody>
                    <a:bodyPr/>
                    <a:lstStyle/>
                    <a:p>
                      <a:pPr algn="l" fontAlgn="b"/>
                      <a:r>
                        <a:rPr lang="nl-NL" sz="700" u="none" strike="noStrike">
                          <a:effectLst/>
                        </a:rPr>
                        <a:t>SLA2</a:t>
                      </a:r>
                      <a:endParaRPr lang="nl-NL" sz="7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3262173694"/>
                  </a:ext>
                </a:extLst>
              </a:tr>
              <a:tr h="99738">
                <a:tc>
                  <a:txBody>
                    <a:bodyPr/>
                    <a:lstStyle/>
                    <a:p>
                      <a:pPr algn="l" fontAlgn="b"/>
                      <a:r>
                        <a:rPr lang="nl-NL" sz="700" u="none" strike="noStrike">
                          <a:effectLst/>
                        </a:rPr>
                        <a:t>CAMP</a:t>
                      </a:r>
                      <a:endParaRPr lang="nl-NL" sz="7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43673588"/>
                  </a:ext>
                </a:extLst>
              </a:tr>
              <a:tr h="99738">
                <a:tc>
                  <a:txBody>
                    <a:bodyPr/>
                    <a:lstStyle/>
                    <a:p>
                      <a:pPr algn="l" fontAlgn="b"/>
                      <a:r>
                        <a:rPr lang="nl-NL" sz="700" u="none" strike="noStrike">
                          <a:effectLst/>
                        </a:rPr>
                        <a:t>PPP1R9A</a:t>
                      </a:r>
                      <a:endParaRPr lang="nl-NL" sz="7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2566160934"/>
                  </a:ext>
                </a:extLst>
              </a:tr>
              <a:tr h="99738">
                <a:tc>
                  <a:txBody>
                    <a:bodyPr/>
                    <a:lstStyle/>
                    <a:p>
                      <a:pPr algn="l" fontAlgn="b"/>
                      <a:r>
                        <a:rPr lang="nl-NL" sz="700" u="none" strike="noStrike">
                          <a:effectLst/>
                        </a:rPr>
                        <a:t>MMP14</a:t>
                      </a:r>
                      <a:endParaRPr lang="nl-NL" sz="7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3099763362"/>
                  </a:ext>
                </a:extLst>
              </a:tr>
              <a:tr h="99738">
                <a:tc>
                  <a:txBody>
                    <a:bodyPr/>
                    <a:lstStyle/>
                    <a:p>
                      <a:pPr algn="l" fontAlgn="b"/>
                      <a:r>
                        <a:rPr lang="nl-NL" sz="700" u="none" strike="noStrike">
                          <a:effectLst/>
                        </a:rPr>
                        <a:t>CPD</a:t>
                      </a:r>
                      <a:endParaRPr lang="nl-NL" sz="7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664612565"/>
                  </a:ext>
                </a:extLst>
              </a:tr>
              <a:tr h="99738">
                <a:tc>
                  <a:txBody>
                    <a:bodyPr/>
                    <a:lstStyle/>
                    <a:p>
                      <a:pPr algn="l" fontAlgn="b"/>
                      <a:r>
                        <a:rPr lang="nl-NL" sz="700" u="none" strike="noStrike">
                          <a:effectLst/>
                        </a:rPr>
                        <a:t>MS4A1</a:t>
                      </a:r>
                      <a:endParaRPr lang="nl-NL" sz="7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3595135819"/>
                  </a:ext>
                </a:extLst>
              </a:tr>
              <a:tr h="99738">
                <a:tc>
                  <a:txBody>
                    <a:bodyPr/>
                    <a:lstStyle/>
                    <a:p>
                      <a:pPr algn="l" fontAlgn="b"/>
                      <a:r>
                        <a:rPr lang="nl-NL" sz="700" u="none" strike="noStrike">
                          <a:effectLst/>
                        </a:rPr>
                        <a:t>NCF4</a:t>
                      </a:r>
                      <a:endParaRPr lang="nl-NL" sz="7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247504310"/>
                  </a:ext>
                </a:extLst>
              </a:tr>
              <a:tr h="99738">
                <a:tc>
                  <a:txBody>
                    <a:bodyPr/>
                    <a:lstStyle/>
                    <a:p>
                      <a:pPr algn="l" fontAlgn="b"/>
                      <a:r>
                        <a:rPr lang="nl-NL" sz="700" u="none" strike="noStrike">
                          <a:effectLst/>
                        </a:rPr>
                        <a:t>SOCS1</a:t>
                      </a:r>
                      <a:endParaRPr lang="nl-NL" sz="7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3584730422"/>
                  </a:ext>
                </a:extLst>
              </a:tr>
              <a:tr h="99738">
                <a:tc>
                  <a:txBody>
                    <a:bodyPr/>
                    <a:lstStyle/>
                    <a:p>
                      <a:pPr algn="l" fontAlgn="b"/>
                      <a:r>
                        <a:rPr lang="nl-NL" sz="700" u="none" strike="noStrike">
                          <a:effectLst/>
                        </a:rPr>
                        <a:t>OSBPL5</a:t>
                      </a:r>
                      <a:endParaRPr lang="nl-NL" sz="7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2514399640"/>
                  </a:ext>
                </a:extLst>
              </a:tr>
              <a:tr h="99738">
                <a:tc>
                  <a:txBody>
                    <a:bodyPr/>
                    <a:lstStyle/>
                    <a:p>
                      <a:pPr algn="l" fontAlgn="b"/>
                      <a:r>
                        <a:rPr lang="nl-NL" sz="700" u="none" strike="noStrike">
                          <a:effectLst/>
                        </a:rPr>
                        <a:t>CSNK1E</a:t>
                      </a:r>
                      <a:endParaRPr lang="nl-NL" sz="7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2685352686"/>
                  </a:ext>
                </a:extLst>
              </a:tr>
              <a:tr h="99738">
                <a:tc>
                  <a:txBody>
                    <a:bodyPr/>
                    <a:lstStyle/>
                    <a:p>
                      <a:pPr algn="l" fontAlgn="b"/>
                      <a:r>
                        <a:rPr lang="nl-NL" sz="700" u="none" strike="noStrike">
                          <a:effectLst/>
                        </a:rPr>
                        <a:t>HOXB2</a:t>
                      </a:r>
                      <a:endParaRPr lang="nl-NL" sz="7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5625254"/>
                  </a:ext>
                </a:extLst>
              </a:tr>
              <a:tr h="99738">
                <a:tc>
                  <a:txBody>
                    <a:bodyPr/>
                    <a:lstStyle/>
                    <a:p>
                      <a:pPr algn="l" fontAlgn="b"/>
                      <a:r>
                        <a:rPr lang="nl-NL" sz="700" u="none" strike="noStrike">
                          <a:effectLst/>
                        </a:rPr>
                        <a:t>STK24</a:t>
                      </a:r>
                      <a:endParaRPr lang="nl-NL" sz="7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994738374"/>
                  </a:ext>
                </a:extLst>
              </a:tr>
              <a:tr h="99738">
                <a:tc>
                  <a:txBody>
                    <a:bodyPr/>
                    <a:lstStyle/>
                    <a:p>
                      <a:pPr algn="l" fontAlgn="b"/>
                      <a:r>
                        <a:rPr lang="nl-NL" sz="700" u="none" strike="noStrike">
                          <a:effectLst/>
                        </a:rPr>
                        <a:t>GSG1</a:t>
                      </a:r>
                      <a:endParaRPr lang="nl-NL" sz="7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3466699794"/>
                  </a:ext>
                </a:extLst>
              </a:tr>
              <a:tr h="99738">
                <a:tc>
                  <a:txBody>
                    <a:bodyPr/>
                    <a:lstStyle/>
                    <a:p>
                      <a:pPr algn="l" fontAlgn="b"/>
                      <a:r>
                        <a:rPr lang="nl-NL" sz="700" u="none" strike="noStrike">
                          <a:effectLst/>
                        </a:rPr>
                        <a:t>TMEM59</a:t>
                      </a:r>
                      <a:endParaRPr lang="nl-NL" sz="7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543343890"/>
                  </a:ext>
                </a:extLst>
              </a:tr>
              <a:tr h="99738">
                <a:tc>
                  <a:txBody>
                    <a:bodyPr/>
                    <a:lstStyle/>
                    <a:p>
                      <a:pPr algn="l" fontAlgn="b"/>
                      <a:r>
                        <a:rPr lang="nl-NL" sz="700" u="none" strike="noStrike">
                          <a:effectLst/>
                        </a:rPr>
                        <a:t>PIPOX</a:t>
                      </a:r>
                      <a:endParaRPr lang="nl-NL" sz="7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496772027"/>
                  </a:ext>
                </a:extLst>
              </a:tr>
              <a:tr h="99738">
                <a:tc>
                  <a:txBody>
                    <a:bodyPr/>
                    <a:lstStyle/>
                    <a:p>
                      <a:pPr algn="l" fontAlgn="b"/>
                      <a:r>
                        <a:rPr lang="nl-NL" sz="700" u="none" strike="noStrike">
                          <a:effectLst/>
                        </a:rPr>
                        <a:t>NCOA2</a:t>
                      </a:r>
                      <a:endParaRPr lang="nl-NL" sz="7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618946552"/>
                  </a:ext>
                </a:extLst>
              </a:tr>
              <a:tr h="99738">
                <a:tc>
                  <a:txBody>
                    <a:bodyPr/>
                    <a:lstStyle/>
                    <a:p>
                      <a:pPr algn="l" fontAlgn="b"/>
                      <a:r>
                        <a:rPr lang="nl-NL" sz="700" u="none" strike="noStrike">
                          <a:effectLst/>
                        </a:rPr>
                        <a:t>PGLYRP2</a:t>
                      </a:r>
                      <a:endParaRPr lang="nl-NL" sz="7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207771499"/>
                  </a:ext>
                </a:extLst>
              </a:tr>
              <a:tr h="99738">
                <a:tc>
                  <a:txBody>
                    <a:bodyPr/>
                    <a:lstStyle/>
                    <a:p>
                      <a:pPr algn="l" fontAlgn="b"/>
                      <a:r>
                        <a:rPr lang="nl-NL" sz="700" u="none" strike="noStrike">
                          <a:effectLst/>
                        </a:rPr>
                        <a:t>ICAM2</a:t>
                      </a:r>
                      <a:endParaRPr lang="nl-NL" sz="7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2187259427"/>
                  </a:ext>
                </a:extLst>
              </a:tr>
              <a:tr h="99738">
                <a:tc>
                  <a:txBody>
                    <a:bodyPr/>
                    <a:lstStyle/>
                    <a:p>
                      <a:pPr algn="l" fontAlgn="b"/>
                      <a:r>
                        <a:rPr lang="nl-NL" sz="700" u="none" strike="noStrike">
                          <a:effectLst/>
                        </a:rPr>
                        <a:t>P2RY2</a:t>
                      </a:r>
                      <a:endParaRPr lang="nl-NL" sz="7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2087812984"/>
                  </a:ext>
                </a:extLst>
              </a:tr>
              <a:tr h="99738">
                <a:tc>
                  <a:txBody>
                    <a:bodyPr/>
                    <a:lstStyle/>
                    <a:p>
                      <a:pPr algn="l" fontAlgn="b"/>
                      <a:r>
                        <a:rPr lang="nl-NL" sz="700" u="none" strike="noStrike">
                          <a:effectLst/>
                        </a:rPr>
                        <a:t>CLEC4A</a:t>
                      </a:r>
                      <a:endParaRPr lang="nl-NL" sz="7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803883156"/>
                  </a:ext>
                </a:extLst>
              </a:tr>
              <a:tr h="99738">
                <a:tc>
                  <a:txBody>
                    <a:bodyPr/>
                    <a:lstStyle/>
                    <a:p>
                      <a:pPr algn="l" fontAlgn="b"/>
                      <a:r>
                        <a:rPr lang="nl-NL" sz="700" u="none" strike="noStrike">
                          <a:effectLst/>
                        </a:rPr>
                        <a:t>IGSF6</a:t>
                      </a:r>
                      <a:endParaRPr lang="nl-NL" sz="7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142074183"/>
                  </a:ext>
                </a:extLst>
              </a:tr>
              <a:tr h="99738">
                <a:tc>
                  <a:txBody>
                    <a:bodyPr/>
                    <a:lstStyle/>
                    <a:p>
                      <a:pPr algn="l" fontAlgn="b"/>
                      <a:r>
                        <a:rPr lang="nl-NL" sz="700" u="none" strike="noStrike">
                          <a:effectLst/>
                        </a:rPr>
                        <a:t>AQP9</a:t>
                      </a:r>
                      <a:endParaRPr lang="nl-NL" sz="7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740188491"/>
                  </a:ext>
                </a:extLst>
              </a:tr>
              <a:tr h="99738">
                <a:tc>
                  <a:txBody>
                    <a:bodyPr/>
                    <a:lstStyle/>
                    <a:p>
                      <a:pPr algn="l" fontAlgn="b"/>
                      <a:r>
                        <a:rPr lang="nl-NL" sz="700" u="none" strike="noStrike">
                          <a:effectLst/>
                        </a:rPr>
                        <a:t>MGP</a:t>
                      </a:r>
                      <a:endParaRPr lang="nl-NL" sz="7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378319586"/>
                  </a:ext>
                </a:extLst>
              </a:tr>
              <a:tr h="99738">
                <a:tc>
                  <a:txBody>
                    <a:bodyPr/>
                    <a:lstStyle/>
                    <a:p>
                      <a:pPr algn="l" fontAlgn="b"/>
                      <a:r>
                        <a:rPr lang="nl-NL" sz="700" u="none" strike="noStrike">
                          <a:effectLst/>
                        </a:rPr>
                        <a:t>TXK</a:t>
                      </a:r>
                      <a:endParaRPr lang="nl-NL" sz="7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2935797489"/>
                  </a:ext>
                </a:extLst>
              </a:tr>
              <a:tr h="94197">
                <a:tc>
                  <a:txBody>
                    <a:bodyPr/>
                    <a:lstStyle/>
                    <a:p>
                      <a:pPr algn="l" fontAlgn="b"/>
                      <a:r>
                        <a:rPr lang="nl-NL" sz="700" u="none" strike="noStrike" dirty="0">
                          <a:effectLst/>
                        </a:rPr>
                        <a:t>HLA-DOB</a:t>
                      </a:r>
                      <a:endParaRPr lang="nl-NL" sz="700" b="0" i="0" u="none" strike="noStrike" dirty="0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3961111559"/>
                  </a:ext>
                </a:extLst>
              </a:tr>
            </a:tbl>
          </a:graphicData>
        </a:graphic>
      </p:graphicFrame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8040" r="4810" b="6252"/>
          <a:stretch/>
        </p:blipFill>
        <p:spPr>
          <a:xfrm>
            <a:off x="1199140" y="421005"/>
            <a:ext cx="4217140" cy="8320912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677983" y="8710167"/>
            <a:ext cx="47814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HBD    1       2      3       4       5      6       7       8       9</a:t>
            </a:r>
            <a:endParaRPr lang="en-GB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391724" y="9079499"/>
            <a:ext cx="1831972" cy="161470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0587402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0923</TotalTime>
  <Words>91</Words>
  <Application>Microsoft Office PowerPoint</Application>
  <PresentationFormat>Widescreen</PresentationFormat>
  <Paragraphs>8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Verdana</vt:lpstr>
      <vt:lpstr>Office Theme</vt:lpstr>
      <vt:lpstr>PowerPoint Presentation</vt:lpstr>
    </vt:vector>
  </TitlesOfParts>
  <Company>Erasmus MC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.M. Wilting</dc:creator>
  <cp:lastModifiedBy>Sivagnanam K.</cp:lastModifiedBy>
  <cp:revision>220</cp:revision>
  <dcterms:created xsi:type="dcterms:W3CDTF">2020-04-30T13:40:18Z</dcterms:created>
  <dcterms:modified xsi:type="dcterms:W3CDTF">2021-10-09T04:18:41Z</dcterms:modified>
</cp:coreProperties>
</file>